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4" r:id="rId3"/>
    <p:sldId id="263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95"/>
    <p:restoredTop sz="96327"/>
  </p:normalViewPr>
  <p:slideViewPr>
    <p:cSldViewPr snapToGrid="0">
      <p:cViewPr varScale="1">
        <p:scale>
          <a:sx n="116" d="100"/>
          <a:sy n="116" d="100"/>
        </p:scale>
        <p:origin x="5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4A23BEF-7A61-B262-8198-427ED5AE9F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7F6A106-D2BE-4BF2-50C4-6AAEC84A80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7A23CCE-D08B-7B2B-CB91-4442FC06A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38D87CF-8F50-26C9-75F1-FA29BF429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3B143CE-8D31-7D59-0448-20520C3AB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0291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E6AF072-E32F-6F37-24E1-47CE77FD54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8745990-21B7-AC77-8B01-5AF0CA5A9A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4BED0D6-C09D-B500-A594-1F0369A7C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B31E47A-C14F-0457-EC8C-E0F7047F6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1B57FD9-48DE-AE47-2C68-11E88494E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0158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E53F9859-A68C-469C-CC44-B182F0DBEB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42DE025-8396-1B97-2F63-1BE6766AB5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D902101-B673-55C0-661A-18891F083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27F2D94-D40F-26AE-C711-DAE09BE72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9B95207-1F86-9408-DD2C-185C6EBDA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7418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23EBA9B-E54B-E8BB-62D1-8DC6BA8B58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3317B42-CB5A-CF3B-CD9B-CFF528164B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35C0F1E-E5A4-F62A-DA22-D54A09069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768F4BD-C556-39EC-B1E0-B017E8DC4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71AFB01-406A-C612-33EF-8A0D4475E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3760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E49A483-0220-DE93-72C3-8B4FF7B581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2AB580A-7A99-2F64-DBA5-74B2C8DC73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5E6E23A-A980-12AF-AA6B-426B979C7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A09FD79-7BFD-A0B7-5FD0-6E0520654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C330688-0A12-FA3B-1CA3-766F273D0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333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9D94BD1-7278-6FD1-AEA4-F27D00D70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6162CD6-9CBE-1834-6BF9-98BF803C4A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35A5B1A-0520-15E6-C44A-990DF43DC2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E90E66A-C1C4-CAA8-E34A-41014C387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843A992-5B3C-22F2-1C8F-1B09B44E8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025D3B2-CBEC-5771-6C58-B696388FF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6460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A136C8-C9F6-33FE-A7EF-960239295C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F97649A-3365-2D37-39AB-090DBCA776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C9CAA9E-C9E2-67F8-2A8D-B8C0A58C24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4004CB9-7933-15AD-CE56-7656ACDB2D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7B76DAC-5F8E-539D-D159-FFBE3F7A6F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15EA97D-B76F-DF61-B451-C07096DC8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82965AC4-DD0A-B1B6-D74C-9F89EAE66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CF70165-46E0-965A-1311-596B2215F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8227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9EC709A-4A05-A53D-7F30-A031FA6EC6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7CFD1DE-0BF8-4F77-E3A6-249FA2C6B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20B6C48-1FA7-D285-336A-55908A2FF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0DD6488-8846-168D-B4EB-0F20C9746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218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A88B648-9425-2664-A5A7-D987FA7F6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64139A4-C82D-603E-680E-4A7547E8E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DCAEBE4-B969-416C-C8FF-4F7C3E22A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3204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D1DC61-947D-AA63-1760-B46311B872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111FE38-3870-54DB-9208-5136E9A66C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F06AE9F-4CCA-68BA-BED5-8E1592D06E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95AAE9F-8CE3-F3D0-54D8-B687B982F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90CABF9-9178-B684-5552-39456065D3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C3BC6C4-0882-F6EB-2BF5-EEFB29994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9229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8680266-360F-4ECC-394E-4A56505BD5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664A5465-3F8B-C0CE-FC32-E1EE8B9F6B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951F7B7-DC87-1E22-79FB-D16A7BFB1C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00338EB-43D6-36B3-AE9E-61D0B8DC3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8AD9B77-5459-4D19-C64A-714A0A0E0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905E97E-1152-FEEB-C223-CB921CBDE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4993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2A4C51CB-7F51-CDC7-C561-BF750B5F8E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7B4C4C5-339B-1408-51AC-A02EFBCF79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C4875B2-8D4B-7320-8115-33C45DF8A8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8805EA-1A30-3644-A7F7-609A86657421}" type="datetimeFigureOut">
              <a:rPr lang="fr-FR" smtClean="0"/>
              <a:t>16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D7DF3D-4EEE-B327-2BDD-7F96C5329D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2D807F-D78E-81B6-DF5D-670C8BE6A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A11E0-9104-D84E-9196-C062855F5CD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0248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52E4D3-AF8A-0EFD-E6C3-2D43C352E966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fr-FR" b="1" dirty="0" err="1"/>
              <a:t>Supplementary</a:t>
            </a:r>
            <a:r>
              <a:rPr lang="fr-FR" b="1" dirty="0"/>
              <a:t> Figures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845B57F-2302-817B-36C3-2CB5F49C47D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43848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41E8D7A0-7434-061C-2D20-D18A1DB06EB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6174" t="19336" r="37081" b="20090"/>
          <a:stretch/>
        </p:blipFill>
        <p:spPr>
          <a:xfrm>
            <a:off x="1738141" y="686082"/>
            <a:ext cx="3616751" cy="2754614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1826CB23-D530-BD49-E5D5-0311F7C1F62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38" t="19549" r="36488" b="20843"/>
          <a:stretch/>
        </p:blipFill>
        <p:spPr>
          <a:xfrm>
            <a:off x="5694234" y="686082"/>
            <a:ext cx="2763164" cy="2742918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C4C82FA9-0387-FDEA-95C7-E82FC1DCEA5B}"/>
              </a:ext>
            </a:extLst>
          </p:cNvPr>
          <p:cNvSpPr txBox="1"/>
          <p:nvPr/>
        </p:nvSpPr>
        <p:spPr>
          <a:xfrm>
            <a:off x="6270979" y="382606"/>
            <a:ext cx="19030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13R4a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LALAPG DFO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C84F187C-E245-414D-0038-793F4823E7DB}"/>
              </a:ext>
            </a:extLst>
          </p:cNvPr>
          <p:cNvSpPr txBox="1"/>
          <p:nvPr/>
        </p:nvSpPr>
        <p:spPr>
          <a:xfrm flipH="1">
            <a:off x="1256840" y="4922415"/>
            <a:ext cx="10120221" cy="6592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ZA" sz="12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Example of mass-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njugated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DFO</a:t>
            </a:r>
          </a:p>
          <a:p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conjugate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by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Maldi-tof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Rapiflex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Bruker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) to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determine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of DFO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conjugat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Peaks of the entire antibody are indicated by an arrow.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DAFE58F7-0770-6A49-9C25-C531238A00F1}"/>
              </a:ext>
            </a:extLst>
          </p:cNvPr>
          <p:cNvSpPr txBox="1"/>
          <p:nvPr/>
        </p:nvSpPr>
        <p:spPr>
          <a:xfrm>
            <a:off x="3258879" y="382606"/>
            <a:ext cx="1534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13R4a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LALAPG</a:t>
            </a:r>
          </a:p>
        </p:txBody>
      </p:sp>
      <p:cxnSp>
        <p:nvCxnSpPr>
          <p:cNvPr id="10" name="Connecteur droit avec flèche 9">
            <a:extLst>
              <a:ext uri="{FF2B5EF4-FFF2-40B4-BE49-F238E27FC236}">
                <a16:creationId xmlns:a16="http://schemas.microsoft.com/office/drawing/2014/main" id="{7B02D369-C3F0-4D7F-CC89-2F3A379720B4}"/>
              </a:ext>
            </a:extLst>
          </p:cNvPr>
          <p:cNvCxnSpPr>
            <a:cxnSpLocks/>
          </p:cNvCxnSpPr>
          <p:nvPr/>
        </p:nvCxnSpPr>
        <p:spPr>
          <a:xfrm>
            <a:off x="6897028" y="931306"/>
            <a:ext cx="219776" cy="1909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C2D3D765-83C7-DA43-95FA-706A0F0C561E}"/>
              </a:ext>
            </a:extLst>
          </p:cNvPr>
          <p:cNvCxnSpPr>
            <a:cxnSpLocks/>
          </p:cNvCxnSpPr>
          <p:nvPr/>
        </p:nvCxnSpPr>
        <p:spPr>
          <a:xfrm>
            <a:off x="3721633" y="2638836"/>
            <a:ext cx="219776" cy="1909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4" name="Tableau 14">
            <a:extLst>
              <a:ext uri="{FF2B5EF4-FFF2-40B4-BE49-F238E27FC236}">
                <a16:creationId xmlns:a16="http://schemas.microsoft.com/office/drawing/2014/main" id="{E55A78E0-C46B-77EE-0994-0C17A338D7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8503680"/>
              </p:ext>
            </p:extLst>
          </p:nvPr>
        </p:nvGraphicFramePr>
        <p:xfrm>
          <a:off x="2766076" y="3409039"/>
          <a:ext cx="2520000" cy="102793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30000">
                  <a:extLst>
                    <a:ext uri="{9D8B030D-6E8A-4147-A177-3AD203B41FA5}">
                      <a16:colId xmlns:a16="http://schemas.microsoft.com/office/drawing/2014/main" val="3785475646"/>
                    </a:ext>
                  </a:extLst>
                </a:gridCol>
                <a:gridCol w="630000">
                  <a:extLst>
                    <a:ext uri="{9D8B030D-6E8A-4147-A177-3AD203B41FA5}">
                      <a16:colId xmlns:a16="http://schemas.microsoft.com/office/drawing/2014/main" val="3866114285"/>
                    </a:ext>
                  </a:extLst>
                </a:gridCol>
                <a:gridCol w="630000">
                  <a:extLst>
                    <a:ext uri="{9D8B030D-6E8A-4147-A177-3AD203B41FA5}">
                      <a16:colId xmlns:a16="http://schemas.microsoft.com/office/drawing/2014/main" val="900019417"/>
                    </a:ext>
                  </a:extLst>
                </a:gridCol>
                <a:gridCol w="630000">
                  <a:extLst>
                    <a:ext uri="{9D8B030D-6E8A-4147-A177-3AD203B41FA5}">
                      <a16:colId xmlns:a16="http://schemas.microsoft.com/office/drawing/2014/main" val="534573647"/>
                    </a:ext>
                  </a:extLst>
                </a:gridCol>
              </a:tblGrid>
              <a:tr h="256984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/z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/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ns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5987181"/>
                  </a:ext>
                </a:extLst>
              </a:tr>
              <a:tr h="256984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42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8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9601221"/>
                  </a:ext>
                </a:extLst>
              </a:tr>
              <a:tr h="256984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74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5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216093"/>
                  </a:ext>
                </a:extLst>
              </a:tr>
              <a:tr h="256984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31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1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3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9445606"/>
                  </a:ext>
                </a:extLst>
              </a:tr>
            </a:tbl>
          </a:graphicData>
        </a:graphic>
      </p:graphicFrame>
      <p:graphicFrame>
        <p:nvGraphicFramePr>
          <p:cNvPr id="15" name="Tableau 14">
            <a:extLst>
              <a:ext uri="{FF2B5EF4-FFF2-40B4-BE49-F238E27FC236}">
                <a16:creationId xmlns:a16="http://schemas.microsoft.com/office/drawing/2014/main" id="{3DBAE215-D342-15D1-823B-387673F81F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4422637"/>
              </p:ext>
            </p:extLst>
          </p:nvPr>
        </p:nvGraphicFramePr>
        <p:xfrm>
          <a:off x="5856804" y="3409039"/>
          <a:ext cx="2520000" cy="1219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89693">
                  <a:extLst>
                    <a:ext uri="{9D8B030D-6E8A-4147-A177-3AD203B41FA5}">
                      <a16:colId xmlns:a16="http://schemas.microsoft.com/office/drawing/2014/main" val="3785475646"/>
                    </a:ext>
                  </a:extLst>
                </a:gridCol>
                <a:gridCol w="481589">
                  <a:extLst>
                    <a:ext uri="{9D8B030D-6E8A-4147-A177-3AD203B41FA5}">
                      <a16:colId xmlns:a16="http://schemas.microsoft.com/office/drawing/2014/main" val="3866114285"/>
                    </a:ext>
                  </a:extLst>
                </a:gridCol>
                <a:gridCol w="585641">
                  <a:extLst>
                    <a:ext uri="{9D8B030D-6E8A-4147-A177-3AD203B41FA5}">
                      <a16:colId xmlns:a16="http://schemas.microsoft.com/office/drawing/2014/main" val="900019417"/>
                    </a:ext>
                  </a:extLst>
                </a:gridCol>
                <a:gridCol w="763077">
                  <a:extLst>
                    <a:ext uri="{9D8B030D-6E8A-4147-A177-3AD203B41FA5}">
                      <a16:colId xmlns:a16="http://schemas.microsoft.com/office/drawing/2014/main" val="534573647"/>
                    </a:ext>
                  </a:extLst>
                </a:gridCol>
              </a:tblGrid>
              <a:tr h="205587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/z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/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ns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5987181"/>
                  </a:ext>
                </a:extLst>
              </a:tr>
              <a:tr h="205587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41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4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2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9601221"/>
                  </a:ext>
                </a:extLst>
              </a:tr>
              <a:tr h="205587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5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77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216093"/>
                  </a:ext>
                </a:extLst>
              </a:tr>
              <a:tr h="205587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9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2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1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9445606"/>
                  </a:ext>
                </a:extLst>
              </a:tr>
              <a:tr h="205587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922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15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9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51045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51230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6FE31AF5-9DFD-6AA9-D527-5D621A5A67D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195" b="24891"/>
          <a:stretch/>
        </p:blipFill>
        <p:spPr>
          <a:xfrm>
            <a:off x="1621417" y="2171699"/>
            <a:ext cx="4299190" cy="206922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231EDA04-4878-AC56-A925-629468D3E38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0489" b="24382"/>
          <a:stretch/>
        </p:blipFill>
        <p:spPr>
          <a:xfrm>
            <a:off x="5920607" y="2171700"/>
            <a:ext cx="4270253" cy="2069224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B9713620-2173-726D-AAEB-68E826C10A92}"/>
              </a:ext>
            </a:extLst>
          </p:cNvPr>
          <p:cNvSpPr txBox="1"/>
          <p:nvPr/>
        </p:nvSpPr>
        <p:spPr>
          <a:xfrm flipH="1">
            <a:off x="939544" y="4515417"/>
            <a:ext cx="9962125" cy="8685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ZA" sz="1200" b="1" dirty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. Binding of D4a WT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and  D4a LALAPG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DFO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njugation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on cancer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by flow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just"/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Anti-AXL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D4a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WT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LALAPG mutations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at 5 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/ml 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stain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AXL positiv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line </a:t>
            </a:r>
            <a:r>
              <a:rPr lang="fr-FR" sz="120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fr-FR" sz="1200" smtClean="0">
                <a:latin typeface="Arial" panose="020B0604020202020204" pitchFamily="34" charset="0"/>
                <a:cs typeface="Arial" panose="020B0604020202020204" pitchFamily="34" charset="0"/>
              </a:rPr>
              <a:t>1h 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at 4°c in PBS-BSA buffer.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3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wash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, a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secondary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fluorescent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anti-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hFc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reveal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binding of D4a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at th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surface of the </a:t>
            </a:r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005121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9</TotalTime>
  <Words>171</Words>
  <Application>Microsoft Office PowerPoint</Application>
  <PresentationFormat>Grand écran</PresentationFormat>
  <Paragraphs>44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Supplementary Figures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 l information</dc:title>
  <dc:creator>Bruno Robert</dc:creator>
  <cp:lastModifiedBy>Deshayes Emmanuel</cp:lastModifiedBy>
  <cp:revision>11</cp:revision>
  <dcterms:created xsi:type="dcterms:W3CDTF">2023-07-28T13:36:33Z</dcterms:created>
  <dcterms:modified xsi:type="dcterms:W3CDTF">2023-08-16T16:20:03Z</dcterms:modified>
</cp:coreProperties>
</file>